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/>
    <p:restoredTop sz="94795"/>
  </p:normalViewPr>
  <p:slideViewPr>
    <p:cSldViewPr snapToGrid="0">
      <p:cViewPr varScale="1">
        <p:scale>
          <a:sx n="120" d="100"/>
          <a:sy n="120" d="100"/>
        </p:scale>
        <p:origin x="14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2D432B-7BB0-724C-9211-6A77CDBB26B2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4F37DF-66C1-984F-863F-E92D068C34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282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4F37DF-66C1-984F-863F-E92D068C344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1639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E0EA5D-7E2E-EE7F-63A3-E31F8953EB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72932F-D9D1-3E1A-40D2-DF140CA477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25C00D-8491-56AD-3CF1-6B80BB90F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756E9F-8A9E-1E4E-3E9A-D83131B53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E591BF-CB1D-EB0D-867C-75CECF8C8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23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4C2C67-F8D6-6BEF-F36B-8FEE9855D9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8A240E-9AE1-85FC-DC34-D1E5D892FF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7F09C6-E510-CC1E-4C36-5DA71EEA67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788B09-FF70-7E7E-BAC5-F341DE240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AD5C26-DE9A-9A48-45A3-6132E03D9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825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6EAAF8E-4E40-DFDC-1EB8-7850526AFB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472979-5D7C-F3F8-DE1C-CABDEC396D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C59BF6-D451-706C-4D08-709946035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6E556D-9AD7-8E5A-DCBE-CA8EE74F0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043AA1-7839-5E8E-CB0D-AD0A1C9AF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377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1E5454-8348-21F9-8747-99C50D19D4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03611D-6C45-FFC6-9C4C-B828F2CAA7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1EFD79-7BAB-5399-43AE-99E1121C2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A8A70F-AF87-C30B-9CA4-2AC6F25B0B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057233-4A66-A760-251E-A91A08ED8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021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D3546B-CECE-A437-BF7C-B80E84AE60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CDAFBA-1881-EE52-823C-EED7945210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714C01-10BA-6069-B7EB-271422DD72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0894C2-F5F2-ADCB-6BD2-DD0163A8E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340BDF-6466-7D6A-FB68-C028B7902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940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270C21-431D-B642-DE95-18483853AA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E5C332-0B9C-A436-DC35-608005F5DA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AFF3CB-1F16-D2A1-AE06-78F7F86DBB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42B32F-03E3-561E-BEFE-AE6B380A7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0222DD-CF12-00DB-426A-5CFCA4DD9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1391A8-B035-434C-B18F-5314CF95D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038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9E4ACD-47A9-47C6-0B5A-CEFD2DBF63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53CE76-E304-4799-E7DB-13F508842F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FCD7CE-C951-2292-206C-E262E3C717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885A9BE-D6BB-41F4-0D67-B5A353AFC6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87F3BA-78CC-061D-849A-4655B2C36F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4535D35-9844-4762-2B5F-814B54887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526B28-5E32-6C63-79FF-6DD610BEE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D513EC4-E5B6-4118-4B52-D9BB562CC0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0055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D80EE1-3FD6-6B4A-AD43-FA36C17740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05F608-0392-9FFD-2360-6A32280C2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1C8559-669F-7A60-10BE-F81E4EB04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8191B81-03B2-6036-2A2A-460F3E10F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4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F0DAA13-7638-5C0A-8E7D-1E1898061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E60871-6771-E574-05B4-79123A65F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420339-7F0F-ED82-45E4-5A6042600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946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5DB23C-5B3A-4372-8935-CE4F23FA34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7D8C5E-2712-245E-8AB8-6609198284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4C4CF2-457C-008E-8D0B-638C69ED9F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856A0B-7F3A-B847-07A6-BDC885C12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16E5D0-6E5E-B18E-B039-3EE70C3E05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B2A954-A3E6-3349-9EE1-CFC3852CB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643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4181D7-6C5F-3243-47FD-DCCFB8277A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52FD3F-0711-5535-529F-C81E4F1295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6BDCBD-A154-04D5-CFCD-6CA266E850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50AA52-949B-4A78-7A9B-5FB09E2C4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7AF52A-3214-4BDC-E8CA-05D97E8C1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B9C406-95A7-3484-4C49-D102ABBA38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4214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B74FCD-73A5-93C2-E859-7428C3C4CE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B7F789-6368-EF8C-EF1D-7B8811580B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97C4EC-6D68-137B-E2C3-09787F2A7E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6113D6-9FD7-AD4A-BD3F-44BE07485183}" type="datetimeFigureOut">
              <a:rPr lang="en-US" smtClean="0"/>
              <a:t>12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6A9F78-1C13-8E2E-964F-9C3CE6D2D3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09C622-BAC1-E676-DCB2-D87535E58B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CD914-C76A-AE4C-BF65-328E0E24A8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813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CA5BB9-7B3D-99E3-1EF0-4ACEDAD311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0"/>
            <a:ext cx="10515600" cy="668338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TABLE 1: IFNNC TRAINING WITH SERIAL EVALUATIONS*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FA2B4E-999B-D676-B20B-E05D33CEC9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-251060" y="489742"/>
            <a:ext cx="6059449" cy="395286"/>
          </a:xfrm>
        </p:spPr>
        <p:txBody>
          <a:bodyPr>
            <a:normAutofit lnSpcReduction="10000"/>
          </a:bodyPr>
          <a:lstStyle/>
          <a:p>
            <a:r>
              <a:rPr lang="en-US" dirty="0"/>
              <a:t>       TIME-DEPENDENT CLINICAL VENU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5CD13C-AE0D-FA3D-F403-C951D0F062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8228" y="913209"/>
            <a:ext cx="4921633" cy="5944791"/>
          </a:xfrm>
        </p:spPr>
        <p:txBody>
          <a:bodyPr>
            <a:normAutofit fontScale="55000" lnSpcReduction="20000"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PRECONCEPTION TIME-PERIOD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PARENTAL PEDIATRIC HEALTH 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OBSTETRICAL SERVICES FOR WOMEN AND PARTNERS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FIRST TRIMESTER ASSIGNMENTS OF MATERNAL LEVELS OF CARE</a:t>
            </a:r>
          </a:p>
          <a:p>
            <a:pPr lvl="2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PRENATAL IMAGING</a:t>
            </a:r>
          </a:p>
          <a:p>
            <a:pPr lvl="2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BIOMARKERS 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ECOND TRIMESTER SURVEILLANCE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MATERNAL LEVELS OF CARE</a:t>
            </a:r>
          </a:p>
          <a:p>
            <a:pPr lvl="2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NATOMIC SURVEYS WITH ADDITIONAL TESTING</a:t>
            </a:r>
          </a:p>
          <a:p>
            <a:pPr lvl="2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MFM AND NEONATAL CONSULTATIONS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MFM INTERDISCINARY SERVICE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FETAL NEUROLOGY CONSULTATION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MFM CONFERENCE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BRAIN SONOGRAPHIC AND MRI FETAL NEUROIMAGING CORRELATIONS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THIRD TRIMESTER SURVEILLANCE WITH ASSIGNED DIAGNSOTIC TESTING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MATERNAL HOSPITALIZATIONS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PERIPARTUM AND NEONATAL SERVICE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LABOR AND DELIVERYWITH RESUSCITATION NEED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CUTE FOLLOWED BY CONVALSCENT STAGES OF CARE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DISCHARGE PLANNNG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PEDIATRIC SERVICE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PRIMARY CARE REFERRAL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INTERVENTION PROGRAM SERVICE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PEDIATRIC SUBSPECIALTY AND THERAPY REFERRAL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INPATIENT/OUTPATIENT REFERRALS</a:t>
            </a:r>
          </a:p>
          <a:p>
            <a:pPr lvl="2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EMERGENCY ROOM</a:t>
            </a:r>
          </a:p>
          <a:p>
            <a:pPr lvl="2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PEDIATRIC INTENSIVE CARE</a:t>
            </a:r>
          </a:p>
          <a:p>
            <a:pPr lvl="2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EPILEPSY SERVICE</a:t>
            </a:r>
          </a:p>
          <a:p>
            <a:pPr lvl="2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LEEP SERVICE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CONTINUITY OF PARTNERSHIPS WITH PARENTS AND ADVOCACY GROUPS</a:t>
            </a:r>
          </a:p>
          <a:p>
            <a:pPr marL="457200" lvl="1" indent="0">
              <a:buNone/>
            </a:pP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*      Adapted from reference 13</a:t>
            </a:r>
          </a:p>
          <a:p>
            <a:pPr marL="457200" lvl="1" indent="0">
              <a:buNone/>
            </a:pP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57200" lvl="1" indent="0">
              <a:buNone/>
            </a:pP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#       Performance metrics of competence based on educators’ descriptive summaries within each teaching </a:t>
            </a:r>
          </a:p>
          <a:p>
            <a:pPr marL="457200" lvl="1" indent="0">
              <a:buNone/>
            </a:pP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        cluster compared to classroom test results help guide trainee readiness for the final  </a:t>
            </a:r>
          </a:p>
          <a:p>
            <a:pPr marL="457200" lvl="1" indent="0">
              <a:buNone/>
            </a:pP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        certification examination.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B55CFE5-444C-A5CE-4F1A-00B6C238DD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808389" y="517923"/>
            <a:ext cx="5543823" cy="395286"/>
          </a:xfrm>
        </p:spPr>
        <p:txBody>
          <a:bodyPr>
            <a:normAutofit lnSpcReduction="10000"/>
          </a:bodyPr>
          <a:lstStyle/>
          <a:p>
            <a:r>
              <a:rPr lang="en-US" dirty="0"/>
              <a:t>       TRAINEE EVALUATION METRICS</a:t>
            </a:r>
            <a:r>
              <a:rPr lang="en-US" baseline="30000" dirty="0"/>
              <a:t> #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DA39A8-7D33-8686-C56C-70CED69ABF4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411096" y="913209"/>
            <a:ext cx="6059450" cy="5781880"/>
          </a:xfrm>
        </p:spPr>
        <p:txBody>
          <a:bodyPr>
            <a:normAutofit fontScale="55000" lnSpcReduction="20000"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EVALUATION OF PARENT’S CHILDHOOD/REPRODUCTIVE HEALTH CARE 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PLANNED VERSUS UNPLANNED PREGNANCY HEALTH STATU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COMMUNICABLE/NON-COMMUNICABLE DISEASES 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DOLESCENT PREGNANCIE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TRUCTURAL, SOCIAL, ENVIRONMENTAL HEALTH DRIVERS IN LMIC OR HIC HEALTHCARE DESERTS 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FIRST EDUCATOR CLUSTER EVALUATIONS 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FIRST TRIMESTER PLACENTAL IMPLANTATION/CORD ABNOMALITIE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INTERPRETATION OF ANEUPLOIDY, WES, GWAS RESULT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TESTS FOR TRIMESTER-SPECIFIC MATERNAL COMMUNUICABLE/NON-COMMUNICABLE DISEASE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DISTINGUISH BRAIN ANOMALOUS FROM DESTRUCTIVE LESION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CONSIDER BRAIN EFFECTS FROM SYSTEMIC MATERNAL-PLACENTAL-FETAL TRIAD ILLNESSE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ERIAL ASSESSMENTS OF FETAL BRAIN STRUCTURE/FUNCTION DISEASE PATHWAY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OUTPATIENT CLINICAND MFF CONFERENCES 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MATERNAL HOSPITALIZATIONS INCLUDING ICU CARE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PERIPARTUM MONITORING MODALITIES THROUGH LABOR AND DELIVERY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ECOND EDUCATOR CLUSTER EVALUATIONS 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RESUSCITATIVE /EARLY ICU STABILIZATION WITH ACUTE NEONATAL INTERVENTION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UBACUTE-CONVALSCENT INTERVENTION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ORGAN-SYSTEM SPECIFIC CONDITIONS REQUIRING PEDIATRIC SUBSPECIALTY SERVICE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NURSING INTERVENTIONS-THERAPY SERVICE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INDIVIDUALIZED DEVELOPMENTAL INFANT INTERVENTION APPROACHS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THIRD EDUCATOR CLUSTER- EVALUATIONS 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HEALTH MAINTENANCE/WELLNESS PROGRAMS AFTER DISCHARGE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EARLY INTERVENTION PROGRAM REFERRAL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THE MEDICALLY FRAGILE CHILD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NEUROPALLIATIVE CARE 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YSTEM-SPECIFIC SURVEILLANCE THROUGHOUT CHILDHOOD 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CUTE DISEASE PRESENTATIONS REQUIRING INTERVENTION ADJUSTMENT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COLLABORATIVE EXPERIENCES DURING ADULT AGE TRANSITIONS </a:t>
            </a:r>
          </a:p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TRANSDISCIPLINARY CARE ASSESSMENTS 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DEMONSTRATE CRITICAL THINKING FOR DIAGNOSES AND INTERVENTION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QUALITATIVE EVALUATIONS OF COMMUNICATION SKILLS AMONG STAKEHOLDERS</a:t>
            </a:r>
          </a:p>
          <a:p>
            <a:pPr lvl="1"/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QUALITIES OF NEUROHUMANISM</a:t>
            </a:r>
          </a:p>
          <a:p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435663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79</TotalTime>
  <Words>361</Words>
  <Application>Microsoft Macintosh PowerPoint</Application>
  <PresentationFormat>Widescreen</PresentationFormat>
  <Paragraphs>7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TABLE 1: IFNNC TRAINING WITH SERIAL EVALUATIONS*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Scher</dc:creator>
  <cp:lastModifiedBy>Mark Scher</cp:lastModifiedBy>
  <cp:revision>18</cp:revision>
  <dcterms:created xsi:type="dcterms:W3CDTF">2023-05-21T16:46:20Z</dcterms:created>
  <dcterms:modified xsi:type="dcterms:W3CDTF">2025-12-14T12:03:15Z</dcterms:modified>
</cp:coreProperties>
</file>